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6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9382C-8971-B26D-6CD3-58FAA2B9BC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29F3960-0A0E-496A-AA26-EFCC1E938B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7D9857-64B1-3220-8C9D-3CFAEF2AA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909CC9-070F-5AC2-D022-1E5BC91DD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0D7906-DCC6-711A-60FB-E99C121FA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6645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6B2C5-08FB-828A-A194-F3A9A74F4E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EA9F1D-3256-D191-B92C-E330764CE2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ED59B9-E9BD-3AE4-4CD0-F739B22ED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EC84CF-4044-689A-01F5-9D91D306E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02E02-7997-D6FC-2E1A-2F36CC2E2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2673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1D9374-4B3E-A21B-B148-90BF33D92F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64DD33-8119-B4D3-EF45-41D13E1D14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69D044-8B69-F9DD-483B-65877B967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FED4B6-DEB1-7568-1C2C-2C9F7EED1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23812-AE7B-0866-A173-34940C702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1111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F3B8C-2FB8-6BA1-0CA1-17EB944D1C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DAA432-1A8A-B5E9-BA9A-21E5A2FCD7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DA8E24-C2AB-DEC9-CC53-CB9AD673B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98530-B743-710B-D574-4D111E8E4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773840-110D-BBFE-9DE6-F67896113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812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C639C-C905-3EAF-3DC4-C401A31B0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9576C0-EB00-742B-6976-F63F9FD3AC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5E7A89-FACC-AAA0-E0C3-DBFED799D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61B56-6276-A618-A87F-407653F54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FEFF6A-BA20-0162-0676-10B959F45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527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014801-731D-3658-1542-7F10C979C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20E732-E624-37E3-0DD0-C83B900A20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0567C3-109D-70F6-2A67-5066976D09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D358D7-5BB7-9E82-582F-1D749EB4A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3409E5-2E3A-208C-02DD-C235533F7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079DF7-E2DC-883D-E768-8192299F5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491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84F829-4343-DE83-AFCA-3F2C7FB7C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751586-D50F-9A29-9801-9A2BB9DAA0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6F3E70-E037-0B4E-4B86-AB91424D1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7AC48E-5DF1-D5DE-6936-5B7225404D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A3C77A9-BD0A-9F16-6D86-64797E6115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6289AE6-973A-C038-0BA8-2630254C8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28F45A-9755-53A6-2F17-0F60CE883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A7A60C-51A0-47EE-4E76-42557D6CB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13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0122DB-B341-1373-5776-7B9F94DA4B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AB9906B-C1CA-949D-69BE-0D4505525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1C05AA-BBE6-8386-0260-CADEA99B0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ED3D65-7D95-00C6-B0C6-C04D4C155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7411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245FD7-F263-4CA3-E898-CB93AFC22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CAC72B-329E-30D9-DF78-A9ED20793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509986-8EA9-2633-BCC9-67CE9FBDE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26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EBFE9-2D3B-C7AC-C655-0268DC453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2CB04D-4FF1-EE46-7124-92DBBCDDBF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29E1CB-8EF6-B979-8BC6-56C24E49BF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8B7B2D-267C-76E8-64D6-2DB0370AC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85EB4D-858E-4A8A-AA7B-4B43EA943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BB24E-E064-6F5C-4021-684208DA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710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BDCD19-3A47-D4FA-3433-8610FF935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ACF915-EE57-ED8A-BAC9-37C84CA74E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1087E1-7141-976B-73B3-88275981A3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995885-3B31-932F-94A9-236829317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9E77D9-CC70-4F73-1081-43518CDDD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930004-4C15-D500-A8CA-E7B6446FF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7119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74853E-E1ED-B3A5-7A37-DDF3DDC9AB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8A8981-8AF6-73BF-E816-555FB1067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75033-DACA-CF51-A9B6-BAF6BC9541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FCA533-AC68-4C15-A4D8-897564F947AD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E6DC67-E695-B778-5630-2867FE6182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E2157-0A41-155B-6D67-B12B8EEEEA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8A7566-5C3A-429D-8E4F-B429236D16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993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CFC9046E-EEF6-5FFD-B420-B177092D9DC4}"/>
              </a:ext>
            </a:extLst>
          </p:cNvPr>
          <p:cNvGrpSpPr/>
          <p:nvPr/>
        </p:nvGrpSpPr>
        <p:grpSpPr>
          <a:xfrm>
            <a:off x="2743201" y="76200"/>
            <a:ext cx="4503535" cy="1457260"/>
            <a:chOff x="68033" y="326854"/>
            <a:chExt cx="4503535" cy="1457260"/>
          </a:xfrm>
        </p:grpSpPr>
        <p:pic>
          <p:nvPicPr>
            <p:cNvPr id="5122" name="Picture 1">
              <a:extLst>
                <a:ext uri="{FF2B5EF4-FFF2-40B4-BE49-F238E27FC236}">
                  <a16:creationId xmlns:a16="http://schemas.microsoft.com/office/drawing/2014/main" id="{B6DC35F6-28FF-9FD5-CFC3-8795251BD93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33" t="8443" r="3143" b="967"/>
            <a:stretch/>
          </p:blipFill>
          <p:spPr bwMode="auto">
            <a:xfrm>
              <a:off x="68033" y="326854"/>
              <a:ext cx="1483138" cy="1457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3" name="Picture 2">
              <a:extLst>
                <a:ext uri="{FF2B5EF4-FFF2-40B4-BE49-F238E27FC236}">
                  <a16:creationId xmlns:a16="http://schemas.microsoft.com/office/drawing/2014/main" id="{9AB0004D-0585-3871-9286-90356AA3D5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7" t="8900" r="1978" b="917"/>
            <a:stretch>
              <a:fillRect/>
            </a:stretch>
          </p:blipFill>
          <p:spPr bwMode="auto">
            <a:xfrm>
              <a:off x="1590166" y="326854"/>
              <a:ext cx="1416401" cy="13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4" name="Picture 3">
              <a:extLst>
                <a:ext uri="{FF2B5EF4-FFF2-40B4-BE49-F238E27FC236}">
                  <a16:creationId xmlns:a16="http://schemas.microsoft.com/office/drawing/2014/main" id="{CC386E97-EEFF-619C-60A5-E3246C0FC5B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8" t="9232" r="726" b="1468"/>
            <a:stretch>
              <a:fillRect/>
            </a:stretch>
          </p:blipFill>
          <p:spPr bwMode="auto">
            <a:xfrm>
              <a:off x="3080780" y="326854"/>
              <a:ext cx="1490788" cy="13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CBB227C-274A-DECD-DD32-1F579B78210B}"/>
              </a:ext>
            </a:extLst>
          </p:cNvPr>
          <p:cNvGrpSpPr/>
          <p:nvPr/>
        </p:nvGrpSpPr>
        <p:grpSpPr>
          <a:xfrm>
            <a:off x="2826155" y="2971800"/>
            <a:ext cx="4534354" cy="1500202"/>
            <a:chOff x="4684795" y="296225"/>
            <a:chExt cx="4306805" cy="1314000"/>
          </a:xfrm>
        </p:grpSpPr>
        <p:pic>
          <p:nvPicPr>
            <p:cNvPr id="5125" name="Picture 4">
              <a:extLst>
                <a:ext uri="{FF2B5EF4-FFF2-40B4-BE49-F238E27FC236}">
                  <a16:creationId xmlns:a16="http://schemas.microsoft.com/office/drawing/2014/main" id="{35BEC6A8-8F1B-7017-1E6D-0ED908BE23B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19" t="9210" r="1179" b="3952"/>
            <a:stretch/>
          </p:blipFill>
          <p:spPr bwMode="auto">
            <a:xfrm>
              <a:off x="4684795" y="305225"/>
              <a:ext cx="1407420" cy="129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6" name="Picture 5">
              <a:extLst>
                <a:ext uri="{FF2B5EF4-FFF2-40B4-BE49-F238E27FC236}">
                  <a16:creationId xmlns:a16="http://schemas.microsoft.com/office/drawing/2014/main" id="{A3C4BCA1-58FD-63A0-01A5-F06F21B2B0F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2" t="9366" r="2631" b="4390"/>
            <a:stretch/>
          </p:blipFill>
          <p:spPr bwMode="auto">
            <a:xfrm>
              <a:off x="6112537" y="305225"/>
              <a:ext cx="1419150" cy="129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7" name="Picture 6">
              <a:extLst>
                <a:ext uri="{FF2B5EF4-FFF2-40B4-BE49-F238E27FC236}">
                  <a16:creationId xmlns:a16="http://schemas.microsoft.com/office/drawing/2014/main" id="{0429A6AA-FA2F-FDC1-7AA3-46902398138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7" t="9295" r="1561" b="705"/>
            <a:stretch/>
          </p:blipFill>
          <p:spPr bwMode="auto">
            <a:xfrm>
              <a:off x="7607642" y="296225"/>
              <a:ext cx="1383958" cy="131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FF28355-F633-133D-1E02-7698F62E7213}"/>
              </a:ext>
            </a:extLst>
          </p:cNvPr>
          <p:cNvGrpSpPr/>
          <p:nvPr/>
        </p:nvGrpSpPr>
        <p:grpSpPr>
          <a:xfrm>
            <a:off x="2793985" y="1524000"/>
            <a:ext cx="4566524" cy="1404000"/>
            <a:chOff x="59687" y="2082868"/>
            <a:chExt cx="4566524" cy="1404000"/>
          </a:xfrm>
        </p:grpSpPr>
        <p:pic>
          <p:nvPicPr>
            <p:cNvPr id="5128" name="Picture 7">
              <a:extLst>
                <a:ext uri="{FF2B5EF4-FFF2-40B4-BE49-F238E27FC236}">
                  <a16:creationId xmlns:a16="http://schemas.microsoft.com/office/drawing/2014/main" id="{68C90911-7ADD-8C19-EE94-AF5E99F6600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75" t="9145" r="1191" b="2982"/>
            <a:stretch/>
          </p:blipFill>
          <p:spPr bwMode="auto">
            <a:xfrm>
              <a:off x="59687" y="2082868"/>
              <a:ext cx="1524705" cy="140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9" name="Picture 8">
              <a:extLst>
                <a:ext uri="{FF2B5EF4-FFF2-40B4-BE49-F238E27FC236}">
                  <a16:creationId xmlns:a16="http://schemas.microsoft.com/office/drawing/2014/main" id="{8FA447E1-3410-CA64-E1FF-F498B2306EB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8996" r="2178" b="4073"/>
            <a:stretch/>
          </p:blipFill>
          <p:spPr bwMode="auto">
            <a:xfrm>
              <a:off x="1588166" y="2082868"/>
              <a:ext cx="1521789" cy="140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0" name="Picture 9">
              <a:extLst>
                <a:ext uri="{FF2B5EF4-FFF2-40B4-BE49-F238E27FC236}">
                  <a16:creationId xmlns:a16="http://schemas.microsoft.com/office/drawing/2014/main" id="{3CF3FF20-55E4-217B-C9EC-F384AFD7524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0" t="9145" r="983" b="2314"/>
            <a:stretch/>
          </p:blipFill>
          <p:spPr bwMode="auto">
            <a:xfrm>
              <a:off x="3096410" y="2082868"/>
              <a:ext cx="1529801" cy="140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06A63DD9-5636-B8AD-E5ED-7790A152314F}"/>
              </a:ext>
            </a:extLst>
          </p:cNvPr>
          <p:cNvGrpSpPr/>
          <p:nvPr/>
        </p:nvGrpSpPr>
        <p:grpSpPr>
          <a:xfrm>
            <a:off x="2857283" y="4495800"/>
            <a:ext cx="4593609" cy="1404000"/>
            <a:chOff x="4627724" y="2086725"/>
            <a:chExt cx="4593609" cy="1404000"/>
          </a:xfrm>
        </p:grpSpPr>
        <p:pic>
          <p:nvPicPr>
            <p:cNvPr id="5131" name="Picture 10">
              <a:extLst>
                <a:ext uri="{FF2B5EF4-FFF2-40B4-BE49-F238E27FC236}">
                  <a16:creationId xmlns:a16="http://schemas.microsoft.com/office/drawing/2014/main" id="{52269DC3-DC7D-4504-8E44-DE5B3462488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9" t="9161" r="1249" b="3544"/>
            <a:stretch/>
          </p:blipFill>
          <p:spPr bwMode="auto">
            <a:xfrm>
              <a:off x="4627724" y="2086725"/>
              <a:ext cx="1527907" cy="140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2" name="Picture 11">
              <a:extLst>
                <a:ext uri="{FF2B5EF4-FFF2-40B4-BE49-F238E27FC236}">
                  <a16:creationId xmlns:a16="http://schemas.microsoft.com/office/drawing/2014/main" id="{8F87586D-DD98-17CA-9635-128D4801861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2" t="9173" r="1188" b="2292"/>
            <a:stretch/>
          </p:blipFill>
          <p:spPr bwMode="auto">
            <a:xfrm>
              <a:off x="6142804" y="2086725"/>
              <a:ext cx="1513275" cy="140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33" name="Picture 12">
              <a:extLst>
                <a:ext uri="{FF2B5EF4-FFF2-40B4-BE49-F238E27FC236}">
                  <a16:creationId xmlns:a16="http://schemas.microsoft.com/office/drawing/2014/main" id="{1721FAA4-940B-FD34-B2E0-ED42C54803C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8" t="9178" r="2367" b="4458"/>
            <a:stretch/>
          </p:blipFill>
          <p:spPr bwMode="auto">
            <a:xfrm>
              <a:off x="7669543" y="2086725"/>
              <a:ext cx="1551790" cy="140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" name="Google Shape;110;p1">
            <a:extLst>
              <a:ext uri="{FF2B5EF4-FFF2-40B4-BE49-F238E27FC236}">
                <a16:creationId xmlns:a16="http://schemas.microsoft.com/office/drawing/2014/main" id="{6007696C-40E7-57F7-A572-DE482812C6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4600" y="-33338"/>
            <a:ext cx="36988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5" tIns="45700" rIns="91425" bIns="4570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>
                <a:srgbClr val="000000"/>
              </a:buClr>
              <a:buSzPts val="1100"/>
              <a:buFontTx/>
              <a:buNone/>
            </a:pPr>
            <a:r>
              <a:rPr lang="en-GB" altLang="el-GR" sz="1100" b="1" dirty="0">
                <a:solidFill>
                  <a:srgbClr val="000000"/>
                </a:solidFill>
                <a:sym typeface="Arial" panose="020B0604020202020204" pitchFamily="34" charset="0"/>
              </a:rPr>
              <a:t>a.</a:t>
            </a:r>
            <a:endParaRPr lang="el-GR" altLang="el-GR" sz="1400" dirty="0">
              <a:solidFill>
                <a:srgbClr val="000000"/>
              </a:solidFill>
              <a:sym typeface="Arial" panose="020B0604020202020204" pitchFamily="34" charset="0"/>
            </a:endParaRPr>
          </a:p>
        </p:txBody>
      </p:sp>
      <p:sp>
        <p:nvSpPr>
          <p:cNvPr id="3" name="Google Shape;111;p1">
            <a:extLst>
              <a:ext uri="{FF2B5EF4-FFF2-40B4-BE49-F238E27FC236}">
                <a16:creationId xmlns:a16="http://schemas.microsoft.com/office/drawing/2014/main" id="{29BE7868-C97D-6819-0875-A70841A36B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6195" y="-23176"/>
            <a:ext cx="3873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5" tIns="45700" rIns="91425" bIns="4570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>
                <a:srgbClr val="000000"/>
              </a:buClr>
              <a:buSzPts val="1100"/>
              <a:buFontTx/>
              <a:buNone/>
            </a:pPr>
            <a:r>
              <a:rPr lang="en-GB" altLang="el-GR" sz="1100" b="1" dirty="0">
                <a:solidFill>
                  <a:srgbClr val="000000"/>
                </a:solidFill>
                <a:sym typeface="Arial" panose="020B0604020202020204" pitchFamily="34" charset="0"/>
              </a:rPr>
              <a:t>b.</a:t>
            </a:r>
            <a:endParaRPr lang="el-GR" altLang="el-GR" sz="1400" dirty="0">
              <a:solidFill>
                <a:srgbClr val="000000"/>
              </a:solidFill>
              <a:sym typeface="Arial" panose="020B0604020202020204" pitchFamily="34" charset="0"/>
            </a:endParaRPr>
          </a:p>
        </p:txBody>
      </p:sp>
      <p:sp>
        <p:nvSpPr>
          <p:cNvPr id="5" name="Google Shape;110;p1">
            <a:extLst>
              <a:ext uri="{FF2B5EF4-FFF2-40B4-BE49-F238E27FC236}">
                <a16:creationId xmlns:a16="http://schemas.microsoft.com/office/drawing/2014/main" id="{B91EBB3B-4BD7-D96D-95EE-DADD6ADA76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4043" y="1526244"/>
            <a:ext cx="369888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5" tIns="45700" rIns="91425" bIns="4570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>
                <a:srgbClr val="000000"/>
              </a:buClr>
              <a:buSzPts val="1100"/>
              <a:buFontTx/>
              <a:buNone/>
            </a:pPr>
            <a:r>
              <a:rPr lang="en-GB" altLang="el-GR" sz="1100" b="1" dirty="0">
                <a:solidFill>
                  <a:srgbClr val="000000"/>
                </a:solidFill>
                <a:sym typeface="Arial" panose="020B0604020202020204" pitchFamily="34" charset="0"/>
              </a:rPr>
              <a:t>d.</a:t>
            </a:r>
            <a:endParaRPr lang="el-GR" altLang="el-GR" sz="1400" dirty="0">
              <a:solidFill>
                <a:srgbClr val="000000"/>
              </a:solidFill>
              <a:sym typeface="Arial" panose="020B0604020202020204" pitchFamily="34" charset="0"/>
            </a:endParaRPr>
          </a:p>
        </p:txBody>
      </p:sp>
      <p:sp>
        <p:nvSpPr>
          <p:cNvPr id="6" name="Google Shape;111;p1">
            <a:extLst>
              <a:ext uri="{FF2B5EF4-FFF2-40B4-BE49-F238E27FC236}">
                <a16:creationId xmlns:a16="http://schemas.microsoft.com/office/drawing/2014/main" id="{B4A31CD2-670A-2AE6-6AAD-5C81ED88EA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9061" y="2834235"/>
            <a:ext cx="387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5" tIns="45700" rIns="91425" bIns="4570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>
                <a:srgbClr val="000000"/>
              </a:buClr>
              <a:buSzPts val="1100"/>
              <a:buFontTx/>
              <a:buNone/>
            </a:pPr>
            <a:r>
              <a:rPr lang="en-GB" altLang="el-GR" sz="1100" b="1" dirty="0">
                <a:solidFill>
                  <a:srgbClr val="000000"/>
                </a:solidFill>
                <a:sym typeface="Arial" panose="020B0604020202020204" pitchFamily="34" charset="0"/>
              </a:rPr>
              <a:t>e.</a:t>
            </a:r>
            <a:endParaRPr lang="el-GR" altLang="el-GR" sz="1400" dirty="0">
              <a:solidFill>
                <a:srgbClr val="000000"/>
              </a:solidFill>
              <a:sym typeface="Arial" panose="020B0604020202020204" pitchFamily="34" charset="0"/>
            </a:endParaRPr>
          </a:p>
        </p:txBody>
      </p:sp>
      <p:sp>
        <p:nvSpPr>
          <p:cNvPr id="7" name="Google Shape;123;p1">
            <a:extLst>
              <a:ext uri="{FF2B5EF4-FFF2-40B4-BE49-F238E27FC236}">
                <a16:creationId xmlns:a16="http://schemas.microsoft.com/office/drawing/2014/main" id="{F9168802-E860-0272-5889-09DE9C0EA5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6986" y="4315673"/>
            <a:ext cx="387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5" tIns="45700" rIns="91425" bIns="4570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>
                <a:srgbClr val="000000"/>
              </a:buClr>
              <a:buSzPts val="1100"/>
              <a:buFontTx/>
              <a:buNone/>
            </a:pPr>
            <a:r>
              <a:rPr lang="en-GB" altLang="el-GR" sz="1100" b="1">
                <a:solidFill>
                  <a:srgbClr val="000000"/>
                </a:solidFill>
                <a:sym typeface="Arial" panose="020B0604020202020204" pitchFamily="34" charset="0"/>
              </a:rPr>
              <a:t>f.</a:t>
            </a:r>
            <a:endParaRPr lang="el-GR" altLang="el-GR" sz="1400">
              <a:solidFill>
                <a:srgbClr val="000000"/>
              </a:solidFill>
              <a:sym typeface="Arial" panose="020B0604020202020204" pitchFamily="34" charset="0"/>
            </a:endParaRPr>
          </a:p>
        </p:txBody>
      </p:sp>
      <p:sp>
        <p:nvSpPr>
          <p:cNvPr id="13" name="TextBox 15">
            <a:extLst>
              <a:ext uri="{FF2B5EF4-FFF2-40B4-BE49-F238E27FC236}">
                <a16:creationId xmlns:a16="http://schemas.microsoft.com/office/drawing/2014/main" id="{10419E03-7E6E-0CDC-B066-9221DF877D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6401" y="5994738"/>
            <a:ext cx="8991599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GB" altLang="el-GR" sz="1200" b="1" dirty="0"/>
              <a:t>Figure S1. Gating strategy for CD55, CD46 and CD59 detection in CD4</a:t>
            </a:r>
            <a:r>
              <a:rPr lang="en-GB" altLang="el-GR" sz="1200" b="1" baseline="30000" dirty="0"/>
              <a:t>+</a:t>
            </a:r>
            <a:r>
              <a:rPr lang="en-GB" altLang="el-GR" sz="1200" b="1" dirty="0"/>
              <a:t>, CD8</a:t>
            </a:r>
            <a:r>
              <a:rPr lang="en-GB" altLang="el-GR" sz="1200" b="1" baseline="30000" dirty="0"/>
              <a:t>+ </a:t>
            </a:r>
            <a:r>
              <a:rPr lang="en-GB" altLang="el-GR" sz="1200" b="1" dirty="0"/>
              <a:t>and B cells by Flow cytometric analysis. </a:t>
            </a:r>
            <a:r>
              <a:rPr lang="en-GB" altLang="el-GR" sz="1200" dirty="0"/>
              <a:t>Representative diagram of gating strategy using the Diva software of the FACS CANTO flow cytometer showing  a) gated CD45</a:t>
            </a:r>
            <a:r>
              <a:rPr lang="en-GB" altLang="el-GR" sz="1200" baseline="30000" dirty="0"/>
              <a:t>+</a:t>
            </a:r>
            <a:r>
              <a:rPr lang="en-GB" altLang="el-GR" sz="1200" dirty="0"/>
              <a:t> cells in order to select for (b) CD4</a:t>
            </a:r>
            <a:r>
              <a:rPr lang="en-GB" altLang="el-GR" sz="1200" baseline="30000" dirty="0"/>
              <a:t>+ </a:t>
            </a:r>
            <a:r>
              <a:rPr lang="en-GB" altLang="el-GR" sz="1200" dirty="0"/>
              <a:t>and CD8</a:t>
            </a:r>
            <a:r>
              <a:rPr lang="en-GB" altLang="el-GR" sz="1200" baseline="30000" dirty="0"/>
              <a:t>+</a:t>
            </a:r>
            <a:r>
              <a:rPr lang="en-GB" altLang="el-GR" sz="1200" dirty="0"/>
              <a:t> and (c) CD19</a:t>
            </a:r>
            <a:r>
              <a:rPr lang="en-GB" altLang="el-GR" sz="1200" baseline="30000" dirty="0"/>
              <a:t>+</a:t>
            </a:r>
            <a:r>
              <a:rPr lang="en-GB" altLang="el-GR" sz="1200" dirty="0"/>
              <a:t> cells. d) gating of CD4</a:t>
            </a:r>
            <a:r>
              <a:rPr lang="en-GB" altLang="el-GR" sz="1200" baseline="30000" dirty="0"/>
              <a:t>+</a:t>
            </a:r>
            <a:r>
              <a:rPr lang="en-GB" altLang="el-GR" sz="1200" dirty="0"/>
              <a:t>CD55, CD46 and CD59</a:t>
            </a:r>
            <a:r>
              <a:rPr lang="en-GB" altLang="el-GR" sz="1200" baseline="30000" dirty="0"/>
              <a:t> </a:t>
            </a:r>
            <a:r>
              <a:rPr lang="en-GB" altLang="el-GR" sz="1200" dirty="0"/>
              <a:t>positive cells e) gating of CD8</a:t>
            </a:r>
            <a:r>
              <a:rPr lang="en-GB" altLang="el-GR" sz="1200" baseline="30000" dirty="0"/>
              <a:t>+</a:t>
            </a:r>
            <a:r>
              <a:rPr lang="en-GB" altLang="el-GR" sz="1200" dirty="0"/>
              <a:t>CD55, CD46 and CD59</a:t>
            </a:r>
            <a:r>
              <a:rPr lang="en-GB" altLang="el-GR" sz="1200" baseline="30000" dirty="0"/>
              <a:t> </a:t>
            </a:r>
            <a:r>
              <a:rPr lang="en-GB" altLang="el-GR" sz="1200" dirty="0"/>
              <a:t>positive cells f) gating of CD19</a:t>
            </a:r>
            <a:r>
              <a:rPr lang="en-GB" altLang="el-GR" sz="1200" baseline="30000" dirty="0"/>
              <a:t>+</a:t>
            </a:r>
            <a:r>
              <a:rPr lang="en-GB" altLang="el-GR" sz="1200" dirty="0"/>
              <a:t>CD55, CD46 and CD59</a:t>
            </a:r>
            <a:r>
              <a:rPr lang="en-GB" altLang="el-GR" sz="1200" baseline="30000" dirty="0"/>
              <a:t> </a:t>
            </a:r>
            <a:r>
              <a:rPr lang="en-GB" altLang="el-GR" sz="1200" dirty="0"/>
              <a:t>positive cells</a:t>
            </a:r>
          </a:p>
        </p:txBody>
      </p:sp>
      <p:sp>
        <p:nvSpPr>
          <p:cNvPr id="16" name="Google Shape;111;p1">
            <a:extLst>
              <a:ext uri="{FF2B5EF4-FFF2-40B4-BE49-F238E27FC236}">
                <a16:creationId xmlns:a16="http://schemas.microsoft.com/office/drawing/2014/main" id="{DE985ADC-9489-189B-DB90-5CA49D842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1734" y="-23176"/>
            <a:ext cx="3873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5" tIns="45700" rIns="91425" bIns="4570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>
                <a:srgbClr val="000000"/>
              </a:buClr>
              <a:buSzPts val="1100"/>
              <a:buFontTx/>
              <a:buNone/>
            </a:pPr>
            <a:r>
              <a:rPr lang="en-GB" altLang="el-GR" sz="1100" b="1" dirty="0">
                <a:solidFill>
                  <a:srgbClr val="000000"/>
                </a:solidFill>
                <a:sym typeface="Arial" panose="020B0604020202020204" pitchFamily="34" charset="0"/>
              </a:rPr>
              <a:t>c.</a:t>
            </a:r>
            <a:endParaRPr lang="el-GR" altLang="el-GR" sz="1400" dirty="0">
              <a:solidFill>
                <a:srgbClr val="000000"/>
              </a:solidFill>
              <a:sym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825BEBC2-6C9C-47CB-A576-5BAA95C4CAEB}"/>
              </a:ext>
            </a:extLst>
          </p:cNvPr>
          <p:cNvGrpSpPr/>
          <p:nvPr/>
        </p:nvGrpSpPr>
        <p:grpSpPr>
          <a:xfrm>
            <a:off x="1796336" y="601240"/>
            <a:ext cx="4299664" cy="3700594"/>
            <a:chOff x="1796336" y="1578702"/>
            <a:chExt cx="4299664" cy="3700594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8A6DF4A-21C3-458D-9658-0E46D0B10E91}"/>
                </a:ext>
              </a:extLst>
            </p:cNvPr>
            <p:cNvGrpSpPr/>
            <p:nvPr/>
          </p:nvGrpSpPr>
          <p:grpSpPr>
            <a:xfrm>
              <a:off x="1958307" y="1578702"/>
              <a:ext cx="4137693" cy="3700594"/>
              <a:chOff x="1958307" y="1578702"/>
              <a:chExt cx="4137693" cy="3700594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DEC11B5B-C7BD-42A6-93A6-4529ED0ACF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58307" y="1578703"/>
                <a:ext cx="1969179" cy="3700593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0245FF67-DFFF-4150-ACDC-48299BB159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32918" y="1578702"/>
                <a:ext cx="1963082" cy="3700593"/>
              </a:xfrm>
              <a:prstGeom prst="rect">
                <a:avLst/>
              </a:prstGeom>
            </p:spPr>
          </p:pic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E1E5F74-4DAC-4F50-AA17-54BB1D3FD2C1}"/>
                </a:ext>
              </a:extLst>
            </p:cNvPr>
            <p:cNvSpPr txBox="1"/>
            <p:nvPr/>
          </p:nvSpPr>
          <p:spPr>
            <a:xfrm>
              <a:off x="1796336" y="1723899"/>
              <a:ext cx="304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a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E113355-A227-473E-B895-62F00805B3E7}"/>
                </a:ext>
              </a:extLst>
            </p:cNvPr>
            <p:cNvSpPr txBox="1"/>
            <p:nvPr/>
          </p:nvSpPr>
          <p:spPr>
            <a:xfrm>
              <a:off x="4108604" y="1723899"/>
              <a:ext cx="3113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)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256971F-4001-4C1B-8BD8-CA76F0A4AF3F}"/>
              </a:ext>
            </a:extLst>
          </p:cNvPr>
          <p:cNvSpPr txBox="1"/>
          <p:nvPr/>
        </p:nvSpPr>
        <p:spPr>
          <a:xfrm>
            <a:off x="1235272" y="4301833"/>
            <a:ext cx="7388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atocrit and hemoglobin levels in patients in response to erythropoietin. A significant decrease in hematocrit and hemoglobin levels was observed in comparison to healthy controls. One-way ANOVA was performed. Post-hoc analysis with uncorrected Fisher’s test. ****p&lt;0.0001.</a:t>
            </a:r>
          </a:p>
        </p:txBody>
      </p:sp>
    </p:spTree>
    <p:extLst>
      <p:ext uri="{BB962C8B-B14F-4D97-AF65-F5344CB8AC3E}">
        <p14:creationId xmlns:p14="http://schemas.microsoft.com/office/powerpoint/2010/main" val="33261158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244AD93-9E85-494F-9BCB-CB90A536BD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429279"/>
              </p:ext>
            </p:extLst>
          </p:nvPr>
        </p:nvGraphicFramePr>
        <p:xfrm>
          <a:off x="2517058" y="634184"/>
          <a:ext cx="7157884" cy="4197504"/>
        </p:xfrm>
        <a:graphic>
          <a:graphicData uri="http://schemas.openxmlformats.org/drawingml/2006/table">
            <a:tbl>
              <a:tblPr firstRow="1" firstCol="1" bandRow="1"/>
              <a:tblGrid>
                <a:gridCol w="1621632">
                  <a:extLst>
                    <a:ext uri="{9D8B030D-6E8A-4147-A177-3AD203B41FA5}">
                      <a16:colId xmlns:a16="http://schemas.microsoft.com/office/drawing/2014/main" val="2462599430"/>
                    </a:ext>
                  </a:extLst>
                </a:gridCol>
                <a:gridCol w="1622513">
                  <a:extLst>
                    <a:ext uri="{9D8B030D-6E8A-4147-A177-3AD203B41FA5}">
                      <a16:colId xmlns:a16="http://schemas.microsoft.com/office/drawing/2014/main" val="1175830406"/>
                    </a:ext>
                  </a:extLst>
                </a:gridCol>
                <a:gridCol w="2248992">
                  <a:extLst>
                    <a:ext uri="{9D8B030D-6E8A-4147-A177-3AD203B41FA5}">
                      <a16:colId xmlns:a16="http://schemas.microsoft.com/office/drawing/2014/main" val="2106575954"/>
                    </a:ext>
                  </a:extLst>
                </a:gridCol>
                <a:gridCol w="1664747">
                  <a:extLst>
                    <a:ext uri="{9D8B030D-6E8A-4147-A177-3AD203B41FA5}">
                      <a16:colId xmlns:a16="http://schemas.microsoft.com/office/drawing/2014/main" val="3111343880"/>
                    </a:ext>
                  </a:extLst>
                </a:gridCol>
              </a:tblGrid>
              <a:tr h="2705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luorochrom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lone/ Cat n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nufacturer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0504113"/>
                  </a:ext>
                </a:extLst>
              </a:tr>
              <a:tr h="93195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45 Pacific Orang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cific Orang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D1</a:t>
                      </a: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l-GR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-160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4191961"/>
                  </a:ext>
                </a:extLst>
              </a:tr>
              <a:tr h="69606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3 Pacific Blu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cific Blu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1/561191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4855906"/>
                  </a:ext>
                </a:extLst>
              </a:tr>
              <a:tr h="54192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4 PerCP-C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rCP-C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M-241 / T9-359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6193418"/>
                  </a:ext>
                </a:extLst>
              </a:tr>
              <a:tr h="4601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8 APC-C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PC-C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M-31 / T4-207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5883829"/>
                  </a:ext>
                </a:extLst>
              </a:tr>
              <a:tr h="4601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19 PE-C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-Cy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T19 / T7-305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3824273"/>
                  </a:ext>
                </a:extLst>
              </a:tr>
              <a:tr h="28306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55 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M-118/1F-230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 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611523"/>
                  </a:ext>
                </a:extLst>
              </a:tr>
              <a:tr h="28306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4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P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M-258/1A-342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7770104"/>
                  </a:ext>
                </a:extLst>
              </a:tr>
              <a:tr h="2705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Hu CD59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M-43/1F-233-T10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bio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901657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011FDB8-866A-45E7-9E6B-01C5096823DF}"/>
              </a:ext>
            </a:extLst>
          </p:cNvPr>
          <p:cNvSpPr txBox="1"/>
          <p:nvPr/>
        </p:nvSpPr>
        <p:spPr>
          <a:xfrm>
            <a:off x="2517057" y="4984955"/>
            <a:ext cx="75413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of antibodies utilized for detection of CD55, CD46 and CD59 on CD4+ and CD8+ T cells and B cells by flow cytometric analysis.</a:t>
            </a:r>
          </a:p>
        </p:txBody>
      </p:sp>
    </p:spTree>
    <p:extLst>
      <p:ext uri="{BB962C8B-B14F-4D97-AF65-F5344CB8AC3E}">
        <p14:creationId xmlns:p14="http://schemas.microsoft.com/office/powerpoint/2010/main" val="2937138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292</Words>
  <Application>Microsoft Office PowerPoint</Application>
  <PresentationFormat>Widescreen</PresentationFormat>
  <Paragraphs>7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ΛΟΒΕΡΔΟΥ ΑΝΤΙΓΟΝΗ</dc:creator>
  <cp:lastModifiedBy>User</cp:lastModifiedBy>
  <cp:revision>7</cp:revision>
  <dcterms:created xsi:type="dcterms:W3CDTF">2024-06-11T09:33:59Z</dcterms:created>
  <dcterms:modified xsi:type="dcterms:W3CDTF">2024-08-02T09:28:30Z</dcterms:modified>
</cp:coreProperties>
</file>